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3" d="100"/>
          <a:sy n="73" d="100"/>
        </p:scale>
        <p:origin x="61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A4F4B-667B-423B-9019-8E50C04B8013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E467A-A903-46BB-A0B5-D64975A6EE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9622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A4F4B-667B-423B-9019-8E50C04B8013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E467A-A903-46BB-A0B5-D64975A6EE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86279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A4F4B-667B-423B-9019-8E50C04B8013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E467A-A903-46BB-A0B5-D64975A6EE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2010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A4F4B-667B-423B-9019-8E50C04B8013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E467A-A903-46BB-A0B5-D64975A6EE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2307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A4F4B-667B-423B-9019-8E50C04B8013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E467A-A903-46BB-A0B5-D64975A6EE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56577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A4F4B-667B-423B-9019-8E50C04B8013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E467A-A903-46BB-A0B5-D64975A6EE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843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A4F4B-667B-423B-9019-8E50C04B8013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E467A-A903-46BB-A0B5-D64975A6EE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8108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A4F4B-667B-423B-9019-8E50C04B8013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E467A-A903-46BB-A0B5-D64975A6EE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40564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A4F4B-667B-423B-9019-8E50C04B8013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E467A-A903-46BB-A0B5-D64975A6EE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24106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A4F4B-667B-423B-9019-8E50C04B8013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E467A-A903-46BB-A0B5-D64975A6EE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15081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A4F4B-667B-423B-9019-8E50C04B8013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E467A-A903-46BB-A0B5-D64975A6EE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13068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6A4F4B-667B-423B-9019-8E50C04B8013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BE467A-A903-46BB-A0B5-D64975A6EE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49919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7902" y="0"/>
            <a:ext cx="6356195" cy="48855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071154" y="5525589"/>
            <a:ext cx="89872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 view of the interaction </a:t>
            </a:r>
            <a:r>
              <a:rPr lang="en-US" dirty="0" smtClean="0"/>
              <a:t>between </a:t>
            </a:r>
            <a:r>
              <a:rPr lang="en-US" dirty="0"/>
              <a:t>unique proteins in the </a:t>
            </a:r>
            <a:r>
              <a:rPr lang="en-US" dirty="0" smtClean="0"/>
              <a:t>Asthm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16084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13263" y="0"/>
            <a:ext cx="9027622" cy="4807131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972491" y="5238206"/>
            <a:ext cx="872598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 view of the interaction between unique proteins in the </a:t>
            </a:r>
            <a:r>
              <a:rPr lang="en-US" dirty="0" smtClean="0"/>
              <a:t>COPD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751858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7691" y="0"/>
            <a:ext cx="6436618" cy="493776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181497" y="5290457"/>
            <a:ext cx="79552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 view of the interaction between unique proteins in the </a:t>
            </a:r>
            <a:r>
              <a:rPr lang="en-US" dirty="0" smtClean="0"/>
              <a:t>PF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313701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38209" y="0"/>
            <a:ext cx="6915582" cy="484632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534194" y="5564777"/>
            <a:ext cx="78246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 view of the interaction between unique proteins in the </a:t>
            </a:r>
            <a:r>
              <a:rPr lang="en-US" dirty="0" smtClean="0"/>
              <a:t>Mustard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594190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44</Words>
  <Application>Microsoft Office PowerPoint</Application>
  <PresentationFormat>Widescreen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Windows User</cp:lastModifiedBy>
  <cp:revision>2</cp:revision>
  <dcterms:created xsi:type="dcterms:W3CDTF">2022-04-05T18:33:36Z</dcterms:created>
  <dcterms:modified xsi:type="dcterms:W3CDTF">2022-04-06T06:25:02Z</dcterms:modified>
</cp:coreProperties>
</file>